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gif" ContentType="video/unknown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1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84" d="100"/>
          <a:sy n="84" d="100"/>
        </p:scale>
        <p:origin x="586" y="77"/>
      </p:cViewPr>
      <p:guideLst>
        <p:guide orient="horz" pos="331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FAF04-D6E9-489B-9FFE-CF426614F7DE}" type="datetimeFigureOut">
              <a:rPr lang="de-DE" smtClean="0"/>
              <a:t>02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3B84F-BA75-480E-9129-B95FE60A8E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39375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FAF04-D6E9-489B-9FFE-CF426614F7DE}" type="datetimeFigureOut">
              <a:rPr lang="de-DE" smtClean="0"/>
              <a:t>02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3B84F-BA75-480E-9129-B95FE60A8E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93791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FAF04-D6E9-489B-9FFE-CF426614F7DE}" type="datetimeFigureOut">
              <a:rPr lang="de-DE" smtClean="0"/>
              <a:t>02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3B84F-BA75-480E-9129-B95FE60A8E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9252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FAF04-D6E9-489B-9FFE-CF426614F7DE}" type="datetimeFigureOut">
              <a:rPr lang="de-DE" smtClean="0"/>
              <a:t>02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3B84F-BA75-480E-9129-B95FE60A8E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9637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FAF04-D6E9-489B-9FFE-CF426614F7DE}" type="datetimeFigureOut">
              <a:rPr lang="de-DE" smtClean="0"/>
              <a:t>02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3B84F-BA75-480E-9129-B95FE60A8E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0384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FAF04-D6E9-489B-9FFE-CF426614F7DE}" type="datetimeFigureOut">
              <a:rPr lang="de-DE" smtClean="0"/>
              <a:t>02.09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3B84F-BA75-480E-9129-B95FE60A8E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39300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FAF04-D6E9-489B-9FFE-CF426614F7DE}" type="datetimeFigureOut">
              <a:rPr lang="de-DE" smtClean="0"/>
              <a:t>02.09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3B84F-BA75-480E-9129-B95FE60A8E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32477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FAF04-D6E9-489B-9FFE-CF426614F7DE}" type="datetimeFigureOut">
              <a:rPr lang="de-DE" smtClean="0"/>
              <a:t>02.09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3B84F-BA75-480E-9129-B95FE60A8E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64816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FAF04-D6E9-489B-9FFE-CF426614F7DE}" type="datetimeFigureOut">
              <a:rPr lang="de-DE" smtClean="0"/>
              <a:t>02.09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3B84F-BA75-480E-9129-B95FE60A8E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37143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FAF04-D6E9-489B-9FFE-CF426614F7DE}" type="datetimeFigureOut">
              <a:rPr lang="de-DE" smtClean="0"/>
              <a:t>02.09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3B84F-BA75-480E-9129-B95FE60A8E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14382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3FAF04-D6E9-489B-9FFE-CF426614F7DE}" type="datetimeFigureOut">
              <a:rPr lang="de-DE" smtClean="0"/>
              <a:t>02.09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3B84F-BA75-480E-9129-B95FE60A8E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90418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3FAF04-D6E9-489B-9FFE-CF426614F7DE}" type="datetimeFigureOut">
              <a:rPr lang="de-DE" smtClean="0"/>
              <a:t>02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03B84F-BA75-480E-9129-B95FE60A8E0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0527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gif"/><Relationship Id="rId7" Type="http://schemas.openxmlformats.org/officeDocument/2006/relationships/image" Target="../media/image2.png"/><Relationship Id="rId2" Type="http://schemas.openxmlformats.org/officeDocument/2006/relationships/video" Target="../media/media1.gif"/><Relationship Id="rId1" Type="http://schemas.microsoft.com/office/2007/relationships/media" Target="../media/media1.gif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SFig.2B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1975105" y="1432972"/>
            <a:ext cx="3748054" cy="3686462"/>
          </a:xfrm>
          <a:prstGeom prst="rect">
            <a:avLst/>
          </a:prstGeom>
        </p:spPr>
      </p:pic>
      <p:pic>
        <p:nvPicPr>
          <p:cNvPr id="5" name="SFig.2C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6290120" y="1438021"/>
            <a:ext cx="3779837" cy="3687763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1743239" y="5513832"/>
            <a:ext cx="4100803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de-DE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le</a:t>
            </a:r>
            <a:r>
              <a:rPr lang="de-DE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2, </a:t>
            </a:r>
            <a:r>
              <a:rPr lang="de-DE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6 B.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un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deo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</a:p>
          <a:p>
            <a:pPr algn="just"/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ick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age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n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rt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utton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algn="just"/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terisks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rk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ular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terial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ported</a:t>
            </a:r>
            <a:endParaRPr lang="de-DE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SC (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een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patocytes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HC,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ey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6129054" y="5510784"/>
            <a:ext cx="4100803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de-DE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le</a:t>
            </a:r>
            <a:r>
              <a:rPr lang="de-DE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2, </a:t>
            </a:r>
            <a:r>
              <a:rPr lang="de-DE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6 C.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un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deo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</a:p>
          <a:p>
            <a:pPr algn="just"/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ck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age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n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rt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utton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algn="just"/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terisk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rks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ular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terial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ported</a:t>
            </a:r>
            <a:endParaRPr lang="de-DE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patocytes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HC,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ey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SC (</a:t>
            </a:r>
            <a:r>
              <a:rPr lang="de-DE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een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180276565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1</Words>
  <Application>Microsoft Office PowerPoint</Application>
  <PresentationFormat>Breitbild</PresentationFormat>
  <Paragraphs>8</Paragraphs>
  <Slides>1</Slides>
  <Notes>0</Notes>
  <HiddenSlides>0</HiddenSlides>
  <MMClips>2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hrist, Bruno</dc:creator>
  <cp:lastModifiedBy>Christ, Bruno</cp:lastModifiedBy>
  <cp:revision>7</cp:revision>
  <dcterms:created xsi:type="dcterms:W3CDTF">2020-07-21T05:38:08Z</dcterms:created>
  <dcterms:modified xsi:type="dcterms:W3CDTF">2020-09-02T05:57:08Z</dcterms:modified>
</cp:coreProperties>
</file>